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1F4E2-76D5-490C-917E-1D6D441032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9D6FA-1236-40BF-B62D-2C2D74FD0B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23D56-35A6-4C57-8148-75C30538B5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1D34D-51A3-4069-B5AD-B271DCC75DA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C689C67-3741-47DD-AA40-6F18E2E5EA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2437FD1-CB35-4ED9-9253-F5E43ED2A3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7F8551-AE26-46E9-B8B5-E1AFC7ECA5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2523AC-6E05-4416-B370-57BA5DC9EB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E78E8BD-7515-4A6D-811C-8CBBE2FAC3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A5E2DC3-E5C2-4166-A8F5-793B5557DE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4B117A-98EF-459E-A534-5AA3367C5D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F9B7A-61FA-41BF-BCEF-0B3E0D676F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7D6B7B4-5ACC-4BCB-AD9B-6F380813F2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5B4366D-1E95-4DD4-A669-AA59F4115F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44CB0AD-332E-4013-9A84-AE04FB0A56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894C90-A3B2-49B9-B4E4-FC5FBBEC06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BAC6EF3-57BE-4ACC-8DC2-031E56A9B5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4002F-46C4-4774-A88E-A4F3D5B222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72F51-BF76-4A93-BA04-0DBD050DC0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AB430-0392-42B0-BA55-34CCEBF4ED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DF9E5-AA41-4BF1-9216-55B593B2DD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97CED-844A-451F-95C6-9894D50FBE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820E9-8E81-4C6C-BDF8-BB626FA74E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A20FD-6217-4B57-A5AA-B6B5B24819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A08B97-B1A5-4773-B26B-5BB95A5E529E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04920" y="6244920"/>
            <a:ext cx="2286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3080" y="6244920"/>
            <a:ext cx="22860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7D1B8F-CEB2-4188-B188-8D63C15BBCF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2" descr=""/>
          <p:cNvPicPr/>
          <p:nvPr/>
        </p:nvPicPr>
        <p:blipFill>
          <a:blip r:embed="rId1"/>
          <a:stretch/>
        </p:blipFill>
        <p:spPr>
          <a:xfrm>
            <a:off x="852480" y="852480"/>
            <a:ext cx="8240760" cy="31896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3" descr=""/>
          <p:cNvPicPr/>
          <p:nvPr/>
        </p:nvPicPr>
        <p:blipFill>
          <a:blip r:embed="rId2"/>
          <a:stretch/>
        </p:blipFill>
        <p:spPr>
          <a:xfrm>
            <a:off x="851040" y="1254240"/>
            <a:ext cx="8242200" cy="2146320"/>
          </a:xfrm>
          <a:prstGeom prst="rect">
            <a:avLst/>
          </a:prstGeom>
          <a:ln w="0">
            <a:noFill/>
          </a:ln>
        </p:spPr>
      </p:pic>
      <p:sp>
        <p:nvSpPr>
          <p:cNvPr id="84" name="Text Box 7"/>
          <p:cNvSpPr/>
          <p:nvPr/>
        </p:nvSpPr>
        <p:spPr>
          <a:xfrm>
            <a:off x="4094280" y="5900760"/>
            <a:ext cx="97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Chr. 1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2"/>
          <p:cNvSpPr/>
          <p:nvPr/>
        </p:nvSpPr>
        <p:spPr>
          <a:xfrm>
            <a:off x="1314360" y="5900760"/>
            <a:ext cx="97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Chr.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8"/>
          <p:cNvSpPr/>
          <p:nvPr/>
        </p:nvSpPr>
        <p:spPr>
          <a:xfrm>
            <a:off x="6853320" y="5900760"/>
            <a:ext cx="973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Chr. 1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25"/>
          <p:cNvSpPr/>
          <p:nvPr/>
        </p:nvSpPr>
        <p:spPr>
          <a:xfrm>
            <a:off x="2635200" y="1695600"/>
            <a:ext cx="1298520" cy="4392360"/>
          </a:xfrm>
          <a:prstGeom prst="rect">
            <a:avLst/>
          </a:prstGeom>
          <a:solidFill>
            <a:srgbClr val="969696">
              <a:alpha val="3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26"/>
          <p:cNvSpPr/>
          <p:nvPr/>
        </p:nvSpPr>
        <p:spPr>
          <a:xfrm>
            <a:off x="5167440" y="1695600"/>
            <a:ext cx="453960" cy="4392360"/>
          </a:xfrm>
          <a:prstGeom prst="rect">
            <a:avLst/>
          </a:prstGeom>
          <a:solidFill>
            <a:srgbClr val="969696">
              <a:alpha val="3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27"/>
          <p:cNvSpPr/>
          <p:nvPr/>
        </p:nvSpPr>
        <p:spPr>
          <a:xfrm flipV="1">
            <a:off x="851040" y="3594240"/>
            <a:ext cx="8242200" cy="14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28"/>
          <p:cNvSpPr/>
          <p:nvPr/>
        </p:nvSpPr>
        <p:spPr>
          <a:xfrm>
            <a:off x="851040" y="3594240"/>
            <a:ext cx="1784160" cy="8636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29"/>
          <p:cNvSpPr/>
          <p:nvPr/>
        </p:nvSpPr>
        <p:spPr>
          <a:xfrm flipH="1">
            <a:off x="851040" y="3594240"/>
            <a:ext cx="1784160" cy="8636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0"/>
          <p:cNvSpPr/>
          <p:nvPr/>
        </p:nvSpPr>
        <p:spPr>
          <a:xfrm>
            <a:off x="2817720" y="579600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rea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31"/>
          <p:cNvSpPr/>
          <p:nvPr/>
        </p:nvSpPr>
        <p:spPr>
          <a:xfrm>
            <a:off x="3933720" y="3594240"/>
            <a:ext cx="1233720" cy="8636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32"/>
          <p:cNvSpPr/>
          <p:nvPr/>
        </p:nvSpPr>
        <p:spPr>
          <a:xfrm flipH="1">
            <a:off x="3933360" y="3594240"/>
            <a:ext cx="1233720" cy="8636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33"/>
          <p:cNvSpPr/>
          <p:nvPr/>
        </p:nvSpPr>
        <p:spPr>
          <a:xfrm>
            <a:off x="5621400" y="3594240"/>
            <a:ext cx="1440" cy="863640"/>
          </a:xfrm>
          <a:prstGeom prst="line">
            <a:avLst/>
          </a:prstGeom>
          <a:ln cap="rnd" w="12600">
            <a:solidFill>
              <a:srgbClr val="eeece1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34"/>
          <p:cNvSpPr/>
          <p:nvPr/>
        </p:nvSpPr>
        <p:spPr>
          <a:xfrm>
            <a:off x="9085320" y="3594240"/>
            <a:ext cx="0" cy="863640"/>
          </a:xfrm>
          <a:prstGeom prst="line">
            <a:avLst/>
          </a:prstGeom>
          <a:ln cap="rnd" w="12600">
            <a:solidFill>
              <a:srgbClr val="eeece1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35"/>
          <p:cNvSpPr/>
          <p:nvPr/>
        </p:nvSpPr>
        <p:spPr>
          <a:xfrm>
            <a:off x="4919760" y="579600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rea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36"/>
          <p:cNvSpPr/>
          <p:nvPr/>
        </p:nvSpPr>
        <p:spPr>
          <a:xfrm>
            <a:off x="851040" y="4475160"/>
            <a:ext cx="1784160" cy="144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37"/>
          <p:cNvSpPr/>
          <p:nvPr/>
        </p:nvSpPr>
        <p:spPr>
          <a:xfrm flipV="1">
            <a:off x="3933720" y="4452480"/>
            <a:ext cx="1231920" cy="180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38"/>
          <p:cNvSpPr/>
          <p:nvPr/>
        </p:nvSpPr>
        <p:spPr>
          <a:xfrm flipV="1">
            <a:off x="5621400" y="4452480"/>
            <a:ext cx="3471840" cy="1800"/>
          </a:xfrm>
          <a:prstGeom prst="line">
            <a:avLst/>
          </a:prstGeom>
          <a:ln w="9360">
            <a:solidFill>
              <a:srgbClr val="be4b4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39"/>
          <p:cNvSpPr/>
          <p:nvPr/>
        </p:nvSpPr>
        <p:spPr>
          <a:xfrm>
            <a:off x="1238400" y="421164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inver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40"/>
          <p:cNvSpPr/>
          <p:nvPr/>
        </p:nvSpPr>
        <p:spPr>
          <a:xfrm>
            <a:off x="4075200" y="4192560"/>
            <a:ext cx="97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inver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3" name="Object 2"/>
          <p:cNvGraphicFramePr/>
          <p:nvPr/>
        </p:nvGraphicFramePr>
        <p:xfrm>
          <a:off x="3949560" y="4697280"/>
          <a:ext cx="1219320" cy="843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4" name="Object 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949560" y="4697280"/>
                    <a:ext cx="1219320" cy="84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5" name="Text Box 57"/>
          <p:cNvSpPr/>
          <p:nvPr/>
        </p:nvSpPr>
        <p:spPr>
          <a:xfrm>
            <a:off x="4680000" y="477684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</a:rPr>
              <a:t>ptch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6" name="Object 3"/>
          <p:cNvGraphicFramePr/>
          <p:nvPr/>
        </p:nvGraphicFramePr>
        <p:xfrm>
          <a:off x="851040" y="4697280"/>
          <a:ext cx="1776240" cy="846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7" name="Object 3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851040" y="4697280"/>
                    <a:ext cx="1776240" cy="84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8" name="Object 4"/>
          <p:cNvGraphicFramePr/>
          <p:nvPr/>
        </p:nvGraphicFramePr>
        <p:xfrm>
          <a:off x="5630760" y="4697280"/>
          <a:ext cx="3427560" cy="8496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09" name="Object 4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630760" y="4697280"/>
                    <a:ext cx="3427560" cy="84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0" name="Text Box 76"/>
          <p:cNvSpPr/>
          <p:nvPr/>
        </p:nvSpPr>
        <p:spPr>
          <a:xfrm>
            <a:off x="5040" y="1731960"/>
            <a:ext cx="835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Huma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Chr. 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77"/>
          <p:cNvSpPr/>
          <p:nvPr/>
        </p:nvSpPr>
        <p:spPr>
          <a:xfrm>
            <a:off x="138600" y="5656320"/>
            <a:ext cx="803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Mous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Chr.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Group 87"/>
          <p:cNvGrpSpPr/>
          <p:nvPr/>
        </p:nvGrpSpPr>
        <p:grpSpPr>
          <a:xfrm>
            <a:off x="4730760" y="4960800"/>
            <a:ext cx="307800" cy="66600"/>
            <a:chOff x="4730760" y="4960800"/>
            <a:chExt cx="307800" cy="66600"/>
          </a:xfrm>
        </p:grpSpPr>
        <p:sp>
          <p:nvSpPr>
            <p:cNvPr id="113" name="Rectangle 56"/>
            <p:cNvSpPr/>
            <p:nvPr/>
          </p:nvSpPr>
          <p:spPr>
            <a:xfrm>
              <a:off x="4730760" y="4960800"/>
              <a:ext cx="58680" cy="66600"/>
            </a:xfrm>
            <a:prstGeom prst="rect">
              <a:avLst/>
            </a:prstGeom>
            <a:solidFill>
              <a:srgbClr val="ff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800" bIns="19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58"/>
            <p:cNvSpPr/>
            <p:nvPr/>
          </p:nvSpPr>
          <p:spPr>
            <a:xfrm>
              <a:off x="4908600" y="4989240"/>
              <a:ext cx="129960" cy="0"/>
            </a:xfrm>
            <a:prstGeom prst="line">
              <a:avLst/>
            </a:prstGeom>
            <a:ln w="9360">
              <a:solidFill>
                <a:srgbClr val="ff00ff"/>
              </a:solidFill>
              <a:miter/>
              <a:tailEnd len="sm" type="arrow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85"/>
            <p:cNvSpPr/>
            <p:nvPr/>
          </p:nvSpPr>
          <p:spPr>
            <a:xfrm>
              <a:off x="4803840" y="4960800"/>
              <a:ext cx="42840" cy="66600"/>
            </a:xfrm>
            <a:prstGeom prst="rect">
              <a:avLst/>
            </a:prstGeom>
            <a:solidFill>
              <a:srgbClr val="ff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800" bIns="19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86"/>
            <p:cNvSpPr/>
            <p:nvPr/>
          </p:nvSpPr>
          <p:spPr>
            <a:xfrm>
              <a:off x="4886280" y="4960800"/>
              <a:ext cx="58680" cy="66600"/>
            </a:xfrm>
            <a:prstGeom prst="rect">
              <a:avLst/>
            </a:prstGeom>
            <a:solidFill>
              <a:srgbClr val="ff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800" bIns="19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TextBox 34"/>
          <p:cNvSpPr/>
          <p:nvPr/>
        </p:nvSpPr>
        <p:spPr>
          <a:xfrm>
            <a:off x="248040" y="271440"/>
            <a:ext cx="686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Additional file 3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rine break of synteny at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TCHD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olymorphic region (Human vs. Mouse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9T19:12:25Z</dcterms:created>
  <dc:creator>Mehdi Seno</dc:creator>
  <dc:description/>
  <dc:language>en-US</dc:language>
  <cp:lastModifiedBy>Mehdi Seno</cp:lastModifiedBy>
  <dcterms:modified xsi:type="dcterms:W3CDTF">2011-03-11T17:38:04Z</dcterms:modified>
  <cp:revision>9</cp:revision>
  <dc:subject/>
  <dc:title>Slide 1</dc:title>
</cp:coreProperties>
</file>